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  <p:sldId id="256" r:id="rId3"/>
    <p:sldId id="257" r:id="rId4"/>
    <p:sldId id="258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>
    <p:restoredLeft sz="15620"/>
    <p:restoredTop sz="94660"/>
  </p:normalViewPr>
  <p:slideViewPr>
    <p:cSldViewPr snapToGrid="0" snapToObjects="1">
      <p:cViewPr varScale="1">
        <p:scale>
          <a:sx n="75" d="100"/>
          <a:sy n="75" d="100"/>
        </p:scale>
        <p:origin x="-1472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Crucial:Users:Eva:Desktop:Users:user:Desktop:Desktop:Documents:3.2020%20combinations%201%20and%202%20P%25%20EC%20%20analysed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Crucial:Users:Eva:Desktop:Users:user:Desktop:Desktop:Documents:3.2020%20combinations%201%20and%202%20P%25%20EC%20%20analysed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Crucial:Users:Eva:Desktop:Users:user:Desktop:Desktop:Documents:3.2020%20combinations%201%20and%202%20P%25%20EC%20%20analysed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Crucial:Users:Eva:Desktop:Users:user:Desktop:Desktop:Documents:3.2020%20combinations%201%20and%202%20P%25%20EC%20%20analysed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Crucial:Users:Eva:Desktop:Users:user:Desktop:Desktop:Documents:3.2020%20combinations%201%20and%202%20P%25%20EC%20%20analysed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Crucial:Users:Eva:Desktop:Users:user:Desktop:Desktop:Documents:3.2020%20combinations%201%20and%202%20P%25%20EC%20%20analysed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Crucial:Users:Eva:Desktop:Users:user:Desktop:Desktop:Documents:3.2020%20combinations%201%20and%202%20P%25%20EC%20%20analysed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Crucial:Users:Eva:Desktop:Users:user:Desktop:Desktop:Documents:3.2020%20combinations%201%20and%202%20P%25%20EC%20%20analysed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Crucial:Users:Eva:Desktop:Users:user:Desktop:Desktop:Documents:3.2020%20combinations%201%20and%202%20P%25%20EC%20%20analysed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Crucial:Users:Eva:Desktop:Users:user:Desktop:Desktop:Documents:3.2020%20combinations%201%20and%202%20P%25%20EC%20%20analyse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3 diff isolates'!$C$4</c:f>
              <c:strCache>
                <c:ptCount val="1"/>
                <c:pt idx="0">
                  <c:v>13.16246448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3 diff isolates'!$D$2:$D$11</c:f>
                <c:numCache>
                  <c:formatCode>General</c:formatCode>
                  <c:ptCount val="10"/>
                  <c:pt idx="0">
                    <c:v>9.150065255154142</c:v>
                  </c:pt>
                  <c:pt idx="1">
                    <c:v>0.436091286105759</c:v>
                  </c:pt>
                  <c:pt idx="2">
                    <c:v>1.602196190344631</c:v>
                  </c:pt>
                  <c:pt idx="3">
                    <c:v>7.758982422608651</c:v>
                  </c:pt>
                  <c:pt idx="4">
                    <c:v>5.726333969350868</c:v>
                  </c:pt>
                  <c:pt idx="5">
                    <c:v>7.964830817477685</c:v>
                  </c:pt>
                  <c:pt idx="6">
                    <c:v>0.183701457517084</c:v>
                  </c:pt>
                  <c:pt idx="7">
                    <c:v>1.209234811655917</c:v>
                  </c:pt>
                  <c:pt idx="8">
                    <c:v>2.785872538345997</c:v>
                  </c:pt>
                  <c:pt idx="9">
                    <c:v>6.38961591025392E-6</c:v>
                  </c:pt>
                </c:numCache>
              </c:numRef>
            </c:plus>
            <c:minus>
              <c:numRef>
                <c:f>'3 diff isolates'!$D$2:$D$11</c:f>
                <c:numCache>
                  <c:formatCode>General</c:formatCode>
                  <c:ptCount val="10"/>
                  <c:pt idx="0">
                    <c:v>9.150065255154142</c:v>
                  </c:pt>
                  <c:pt idx="1">
                    <c:v>0.436091286105759</c:v>
                  </c:pt>
                  <c:pt idx="2">
                    <c:v>1.602196190344631</c:v>
                  </c:pt>
                  <c:pt idx="3">
                    <c:v>7.758982422608651</c:v>
                  </c:pt>
                  <c:pt idx="4">
                    <c:v>5.726333969350868</c:v>
                  </c:pt>
                  <c:pt idx="5">
                    <c:v>7.964830817477685</c:v>
                  </c:pt>
                  <c:pt idx="6">
                    <c:v>0.183701457517084</c:v>
                  </c:pt>
                  <c:pt idx="7">
                    <c:v>1.209234811655917</c:v>
                  </c:pt>
                  <c:pt idx="8">
                    <c:v>2.785872538345997</c:v>
                  </c:pt>
                  <c:pt idx="9">
                    <c:v>6.38961591025392E-6</c:v>
                  </c:pt>
                </c:numCache>
              </c:numRef>
            </c:minus>
          </c:errBars>
          <c:cat>
            <c:strRef>
              <c:f>'3 diff isolates'!$B$2:$B$11</c:f>
              <c:strCache>
                <c:ptCount val="10"/>
                <c:pt idx="0">
                  <c:v>25+0</c:v>
                </c:pt>
                <c:pt idx="1">
                  <c:v>0+5</c:v>
                </c:pt>
                <c:pt idx="2">
                  <c:v>0+10</c:v>
                </c:pt>
                <c:pt idx="3">
                  <c:v>10+0</c:v>
                </c:pt>
                <c:pt idx="4">
                  <c:v>10+5</c:v>
                </c:pt>
                <c:pt idx="5">
                  <c:v>10+10</c:v>
                </c:pt>
                <c:pt idx="6">
                  <c:v>Art 10ng/ml</c:v>
                </c:pt>
                <c:pt idx="7">
                  <c:v>Art 5ng/ml</c:v>
                </c:pt>
                <c:pt idx="8">
                  <c:v>Art 1ng/ml</c:v>
                </c:pt>
                <c:pt idx="9">
                  <c:v>No Drug</c:v>
                </c:pt>
              </c:strCache>
            </c:strRef>
          </c:cat>
          <c:val>
            <c:numRef>
              <c:f>'3 diff isolates'!$C$2:$C$11</c:f>
              <c:numCache>
                <c:formatCode>General</c:formatCode>
                <c:ptCount val="10"/>
                <c:pt idx="0">
                  <c:v>95.25585657311451</c:v>
                </c:pt>
                <c:pt idx="1">
                  <c:v>-4.474097905760432</c:v>
                </c:pt>
                <c:pt idx="2">
                  <c:v>13.16246447950703</c:v>
                </c:pt>
                <c:pt idx="3">
                  <c:v>90.61893359451159</c:v>
                </c:pt>
                <c:pt idx="4">
                  <c:v>90.76404484744931</c:v>
                </c:pt>
                <c:pt idx="5">
                  <c:v>91.66616595441495</c:v>
                </c:pt>
                <c:pt idx="6">
                  <c:v>98.81285852011553</c:v>
                </c:pt>
                <c:pt idx="7">
                  <c:v>59.43274381536564</c:v>
                </c:pt>
                <c:pt idx="8">
                  <c:v>42.98106383961179</c:v>
                </c:pt>
                <c:pt idx="9">
                  <c:v>-4.518140739318E-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3483816"/>
        <c:axId val="2090884152"/>
      </c:barChart>
      <c:catAx>
        <c:axId val="2093483816"/>
        <c:scaling>
          <c:orientation val="minMax"/>
        </c:scaling>
        <c:delete val="0"/>
        <c:axPos val="b"/>
        <c:majorTickMark val="out"/>
        <c:minorTickMark val="none"/>
        <c:tickLblPos val="nextTo"/>
        <c:crossAx val="2090884152"/>
        <c:crosses val="autoZero"/>
        <c:auto val="1"/>
        <c:lblAlgn val="ctr"/>
        <c:lblOffset val="100"/>
        <c:noMultiLvlLbl val="0"/>
      </c:catAx>
      <c:valAx>
        <c:axId val="209088415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NF54 inhibition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09348381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3 diff isolates'!$L$61:$L$72</c:f>
                <c:numCache>
                  <c:formatCode>General</c:formatCode>
                  <c:ptCount val="12"/>
                  <c:pt idx="0">
                    <c:v>1.516240993726658</c:v>
                  </c:pt>
                  <c:pt idx="1">
                    <c:v>0.247983340095473</c:v>
                  </c:pt>
                  <c:pt idx="2">
                    <c:v>1.119467649573891</c:v>
                  </c:pt>
                  <c:pt idx="3">
                    <c:v>0.382602867575887</c:v>
                  </c:pt>
                  <c:pt idx="4">
                    <c:v>0.474710965325641</c:v>
                  </c:pt>
                  <c:pt idx="5">
                    <c:v>2.600282451858345</c:v>
                  </c:pt>
                  <c:pt idx="6">
                    <c:v>0.425114297306549</c:v>
                  </c:pt>
                  <c:pt idx="7">
                    <c:v>0.134619527480404</c:v>
                  </c:pt>
                  <c:pt idx="8">
                    <c:v>0.887890898471969</c:v>
                  </c:pt>
                  <c:pt idx="9">
                    <c:v>1.027359551824137</c:v>
                  </c:pt>
                  <c:pt idx="10">
                    <c:v>0.0354261914422248</c:v>
                  </c:pt>
                  <c:pt idx="11">
                    <c:v>0.814278543242889</c:v>
                  </c:pt>
                </c:numCache>
              </c:numRef>
            </c:plus>
            <c:minus>
              <c:numRef>
                <c:f>'3 diff isolates'!$L$61:$L$72</c:f>
                <c:numCache>
                  <c:formatCode>General</c:formatCode>
                  <c:ptCount val="12"/>
                  <c:pt idx="0">
                    <c:v>1.516240993726658</c:v>
                  </c:pt>
                  <c:pt idx="1">
                    <c:v>0.247983340095473</c:v>
                  </c:pt>
                  <c:pt idx="2">
                    <c:v>1.119467649573891</c:v>
                  </c:pt>
                  <c:pt idx="3">
                    <c:v>0.382602867575887</c:v>
                  </c:pt>
                  <c:pt idx="4">
                    <c:v>0.474710965325641</c:v>
                  </c:pt>
                  <c:pt idx="5">
                    <c:v>2.600282451858345</c:v>
                  </c:pt>
                  <c:pt idx="6">
                    <c:v>0.425114297306549</c:v>
                  </c:pt>
                  <c:pt idx="7">
                    <c:v>0.134619527480404</c:v>
                  </c:pt>
                  <c:pt idx="8">
                    <c:v>0.887890898471969</c:v>
                  </c:pt>
                  <c:pt idx="9">
                    <c:v>1.027359551824137</c:v>
                  </c:pt>
                  <c:pt idx="10">
                    <c:v>0.0354261914422248</c:v>
                  </c:pt>
                  <c:pt idx="11">
                    <c:v>0.814278543242889</c:v>
                  </c:pt>
                </c:numCache>
              </c:numRef>
            </c:minus>
          </c:errBars>
          <c:cat>
            <c:strRef>
              <c:f>'3 diff isolates'!$J$61:$J$72</c:f>
              <c:strCache>
                <c:ptCount val="12"/>
                <c:pt idx="0">
                  <c:v>10+0</c:v>
                </c:pt>
                <c:pt idx="1">
                  <c:v>5+0</c:v>
                </c:pt>
                <c:pt idx="2">
                  <c:v>5+10</c:v>
                </c:pt>
                <c:pt idx="3">
                  <c:v>5+25</c:v>
                </c:pt>
                <c:pt idx="4">
                  <c:v>5+50</c:v>
                </c:pt>
                <c:pt idx="5">
                  <c:v>0+5</c:v>
                </c:pt>
                <c:pt idx="6">
                  <c:v>0+10</c:v>
                </c:pt>
                <c:pt idx="7">
                  <c:v>0+25</c:v>
                </c:pt>
                <c:pt idx="8">
                  <c:v>0+50</c:v>
                </c:pt>
                <c:pt idx="9">
                  <c:v>Art 10ng/ml</c:v>
                </c:pt>
                <c:pt idx="10">
                  <c:v>Art 2.5ng/ml</c:v>
                </c:pt>
                <c:pt idx="11">
                  <c:v>Art 1ng/ml</c:v>
                </c:pt>
              </c:strCache>
            </c:strRef>
          </c:cat>
          <c:val>
            <c:numRef>
              <c:f>'3 diff isolates'!$K$61:$K$72</c:f>
              <c:numCache>
                <c:formatCode>General</c:formatCode>
                <c:ptCount val="12"/>
                <c:pt idx="0">
                  <c:v>70.6613226452906</c:v>
                </c:pt>
                <c:pt idx="1">
                  <c:v>31.75851703406812</c:v>
                </c:pt>
                <c:pt idx="2">
                  <c:v>61.22244488977956</c:v>
                </c:pt>
                <c:pt idx="3">
                  <c:v>77.66533066132264</c:v>
                </c:pt>
                <c:pt idx="4">
                  <c:v>82.84068136272545</c:v>
                </c:pt>
                <c:pt idx="5">
                  <c:v>23.40180360721443</c:v>
                </c:pt>
                <c:pt idx="6">
                  <c:v>13.62725450901804</c:v>
                </c:pt>
                <c:pt idx="7">
                  <c:v>65.78657314629258</c:v>
                </c:pt>
                <c:pt idx="8">
                  <c:v>81.4929859719439</c:v>
                </c:pt>
                <c:pt idx="9">
                  <c:v>80.53607214428854</c:v>
                </c:pt>
                <c:pt idx="10">
                  <c:v>74.0230460921843</c:v>
                </c:pt>
                <c:pt idx="11">
                  <c:v>42.575150300601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19757368"/>
        <c:axId val="2119745032"/>
      </c:barChart>
      <c:catAx>
        <c:axId val="2119757368"/>
        <c:scaling>
          <c:orientation val="minMax"/>
        </c:scaling>
        <c:delete val="0"/>
        <c:axPos val="b"/>
        <c:majorTickMark val="out"/>
        <c:minorTickMark val="none"/>
        <c:tickLblPos val="nextTo"/>
        <c:crossAx val="2119745032"/>
        <c:crosses val="autoZero"/>
        <c:auto val="1"/>
        <c:lblAlgn val="ctr"/>
        <c:lblOffset val="100"/>
        <c:noMultiLvlLbl val="0"/>
      </c:catAx>
      <c:valAx>
        <c:axId val="211974503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am_WT inhibition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1975736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3087739032621"/>
          <c:y val="0.0555555555555555"/>
          <c:w val="0.770473244415877"/>
          <c:h val="0.796643336249635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3 diff isolates'!$I$3:$I$15</c:f>
                <c:numCache>
                  <c:formatCode>General</c:formatCode>
                  <c:ptCount val="13"/>
                  <c:pt idx="0">
                    <c:v>0.436091286105759</c:v>
                  </c:pt>
                  <c:pt idx="1">
                    <c:v>1.602196190344631</c:v>
                  </c:pt>
                  <c:pt idx="2">
                    <c:v>7.94229258065157</c:v>
                  </c:pt>
                  <c:pt idx="3">
                    <c:v>0.536727736745564</c:v>
                  </c:pt>
                  <c:pt idx="4">
                    <c:v>4.370969310678352</c:v>
                  </c:pt>
                  <c:pt idx="5">
                    <c:v>7.256969377550604</c:v>
                  </c:pt>
                  <c:pt idx="6">
                    <c:v>2.882367699684246</c:v>
                  </c:pt>
                  <c:pt idx="7">
                    <c:v>8.823075485685131</c:v>
                  </c:pt>
                  <c:pt idx="8">
                    <c:v>8.6957961273621</c:v>
                  </c:pt>
                  <c:pt idx="9">
                    <c:v>0.183701457517084</c:v>
                  </c:pt>
                  <c:pt idx="10">
                    <c:v>1.209234811655917</c:v>
                  </c:pt>
                  <c:pt idx="11">
                    <c:v>2.785872538345997</c:v>
                  </c:pt>
                  <c:pt idx="12">
                    <c:v>6.38961591025392E-6</c:v>
                  </c:pt>
                </c:numCache>
              </c:numRef>
            </c:plus>
            <c:minus>
              <c:numRef>
                <c:f>'3 diff isolates'!$I$3:$I$15</c:f>
                <c:numCache>
                  <c:formatCode>General</c:formatCode>
                  <c:ptCount val="13"/>
                  <c:pt idx="0">
                    <c:v>0.436091286105759</c:v>
                  </c:pt>
                  <c:pt idx="1">
                    <c:v>1.602196190344631</c:v>
                  </c:pt>
                  <c:pt idx="2">
                    <c:v>7.94229258065157</c:v>
                  </c:pt>
                  <c:pt idx="3">
                    <c:v>0.536727736745564</c:v>
                  </c:pt>
                  <c:pt idx="4">
                    <c:v>4.370969310678352</c:v>
                  </c:pt>
                  <c:pt idx="5">
                    <c:v>7.256969377550604</c:v>
                  </c:pt>
                  <c:pt idx="6">
                    <c:v>2.882367699684246</c:v>
                  </c:pt>
                  <c:pt idx="7">
                    <c:v>8.823075485685131</c:v>
                  </c:pt>
                  <c:pt idx="8">
                    <c:v>8.6957961273621</c:v>
                  </c:pt>
                  <c:pt idx="9">
                    <c:v>0.183701457517084</c:v>
                  </c:pt>
                  <c:pt idx="10">
                    <c:v>1.209234811655917</c:v>
                  </c:pt>
                  <c:pt idx="11">
                    <c:v>2.785872538345997</c:v>
                  </c:pt>
                  <c:pt idx="12">
                    <c:v>6.38961591025392E-6</c:v>
                  </c:pt>
                </c:numCache>
              </c:numRef>
            </c:minus>
          </c:errBars>
          <c:cat>
            <c:strRef>
              <c:f>'3 diff isolates'!$G$3:$G$15</c:f>
              <c:strCache>
                <c:ptCount val="13"/>
                <c:pt idx="0">
                  <c:v>0+5</c:v>
                </c:pt>
                <c:pt idx="1">
                  <c:v>0+10</c:v>
                </c:pt>
                <c:pt idx="2">
                  <c:v>0+25</c:v>
                </c:pt>
                <c:pt idx="3">
                  <c:v>0+50</c:v>
                </c:pt>
                <c:pt idx="4">
                  <c:v>5+0</c:v>
                </c:pt>
                <c:pt idx="5">
                  <c:v>5+5</c:v>
                </c:pt>
                <c:pt idx="6">
                  <c:v>5+10</c:v>
                </c:pt>
                <c:pt idx="7">
                  <c:v>5+25</c:v>
                </c:pt>
                <c:pt idx="8">
                  <c:v>5+50</c:v>
                </c:pt>
                <c:pt idx="9">
                  <c:v>Art 10ng/ml</c:v>
                </c:pt>
                <c:pt idx="10">
                  <c:v>Art 5ng/ml</c:v>
                </c:pt>
                <c:pt idx="11">
                  <c:v>Art 1ng/ml</c:v>
                </c:pt>
                <c:pt idx="12">
                  <c:v>No Drug</c:v>
                </c:pt>
              </c:strCache>
            </c:strRef>
          </c:cat>
          <c:val>
            <c:numRef>
              <c:f>'3 diff isolates'!$H$3:$H$15</c:f>
              <c:numCache>
                <c:formatCode>General</c:formatCode>
                <c:ptCount val="13"/>
                <c:pt idx="0">
                  <c:v>-4.474097905760432</c:v>
                </c:pt>
                <c:pt idx="1">
                  <c:v>13.16246447950703</c:v>
                </c:pt>
                <c:pt idx="2">
                  <c:v>45.43893240310237</c:v>
                </c:pt>
                <c:pt idx="3">
                  <c:v>97.84484686620401</c:v>
                </c:pt>
                <c:pt idx="4">
                  <c:v>75.79213567852328</c:v>
                </c:pt>
                <c:pt idx="5">
                  <c:v>72.48788539886981</c:v>
                </c:pt>
                <c:pt idx="6">
                  <c:v>82.68376533558563</c:v>
                </c:pt>
                <c:pt idx="7">
                  <c:v>92.42829197434662</c:v>
                </c:pt>
                <c:pt idx="8">
                  <c:v>95.4505654130921</c:v>
                </c:pt>
                <c:pt idx="9">
                  <c:v>98.81285852011553</c:v>
                </c:pt>
                <c:pt idx="10">
                  <c:v>59.43274381536564</c:v>
                </c:pt>
                <c:pt idx="11">
                  <c:v>42.98106383961179</c:v>
                </c:pt>
                <c:pt idx="12">
                  <c:v>-4.518140739318E-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17166728"/>
        <c:axId val="2121825320"/>
      </c:barChart>
      <c:catAx>
        <c:axId val="2117166728"/>
        <c:scaling>
          <c:orientation val="minMax"/>
        </c:scaling>
        <c:delete val="0"/>
        <c:axPos val="b"/>
        <c:majorTickMark val="out"/>
        <c:minorTickMark val="none"/>
        <c:tickLblPos val="nextTo"/>
        <c:crossAx val="2121825320"/>
        <c:crosses val="autoZero"/>
        <c:auto val="1"/>
        <c:lblAlgn val="ctr"/>
        <c:lblOffset val="100"/>
        <c:noMultiLvlLbl val="0"/>
      </c:catAx>
      <c:valAx>
        <c:axId val="212182532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NF54 inhibition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1716672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3 diff isolates'!$N$3:$N$16</c:f>
                <c:numCache>
                  <c:formatCode>General</c:formatCode>
                  <c:ptCount val="14"/>
                  <c:pt idx="0">
                    <c:v>0.436091286105759</c:v>
                  </c:pt>
                  <c:pt idx="1">
                    <c:v>1.602196190344631</c:v>
                  </c:pt>
                  <c:pt idx="2">
                    <c:v>7.94229258065157</c:v>
                  </c:pt>
                  <c:pt idx="3">
                    <c:v>0.536727736745564</c:v>
                  </c:pt>
                  <c:pt idx="4">
                    <c:v>3.78414414119445</c:v>
                  </c:pt>
                  <c:pt idx="5">
                    <c:v>4.972324940173478</c:v>
                  </c:pt>
                  <c:pt idx="6">
                    <c:v>8.94129458704006</c:v>
                  </c:pt>
                  <c:pt idx="7">
                    <c:v>1.104210765081466</c:v>
                  </c:pt>
                  <c:pt idx="8">
                    <c:v>0.917430973485077</c:v>
                  </c:pt>
                  <c:pt idx="9">
                    <c:v>8.223157796773728</c:v>
                  </c:pt>
                  <c:pt idx="10">
                    <c:v>0.183701457517084</c:v>
                  </c:pt>
                  <c:pt idx="11">
                    <c:v>1.209234811655917</c:v>
                  </c:pt>
                  <c:pt idx="12">
                    <c:v>2.785872538345997</c:v>
                  </c:pt>
                  <c:pt idx="13">
                    <c:v>6.38961591025392E-6</c:v>
                  </c:pt>
                </c:numCache>
              </c:numRef>
            </c:plus>
            <c:minus>
              <c:numRef>
                <c:f>'3 diff isolates'!$N$3:$N$16</c:f>
                <c:numCache>
                  <c:formatCode>General</c:formatCode>
                  <c:ptCount val="14"/>
                  <c:pt idx="0">
                    <c:v>0.436091286105759</c:v>
                  </c:pt>
                  <c:pt idx="1">
                    <c:v>1.602196190344631</c:v>
                  </c:pt>
                  <c:pt idx="2">
                    <c:v>7.94229258065157</c:v>
                  </c:pt>
                  <c:pt idx="3">
                    <c:v>0.536727736745564</c:v>
                  </c:pt>
                  <c:pt idx="4">
                    <c:v>3.78414414119445</c:v>
                  </c:pt>
                  <c:pt idx="5">
                    <c:v>4.972324940173478</c:v>
                  </c:pt>
                  <c:pt idx="6">
                    <c:v>8.94129458704006</c:v>
                  </c:pt>
                  <c:pt idx="7">
                    <c:v>1.104210765081466</c:v>
                  </c:pt>
                  <c:pt idx="8">
                    <c:v>0.917430973485077</c:v>
                  </c:pt>
                  <c:pt idx="9">
                    <c:v>8.223157796773728</c:v>
                  </c:pt>
                  <c:pt idx="10">
                    <c:v>0.183701457517084</c:v>
                  </c:pt>
                  <c:pt idx="11">
                    <c:v>1.209234811655917</c:v>
                  </c:pt>
                  <c:pt idx="12">
                    <c:v>2.785872538345997</c:v>
                  </c:pt>
                  <c:pt idx="13">
                    <c:v>6.38961591025392E-6</c:v>
                  </c:pt>
                </c:numCache>
              </c:numRef>
            </c:minus>
          </c:errBars>
          <c:cat>
            <c:strRef>
              <c:f>'3 diff isolates'!$L$3:$L$16</c:f>
              <c:strCache>
                <c:ptCount val="14"/>
                <c:pt idx="0">
                  <c:v>0+5</c:v>
                </c:pt>
                <c:pt idx="1">
                  <c:v>0+10</c:v>
                </c:pt>
                <c:pt idx="2">
                  <c:v>0+25</c:v>
                </c:pt>
                <c:pt idx="3">
                  <c:v>0+50</c:v>
                </c:pt>
                <c:pt idx="4">
                  <c:v>2.5+0</c:v>
                </c:pt>
                <c:pt idx="5">
                  <c:v>2.5+5</c:v>
                </c:pt>
                <c:pt idx="6">
                  <c:v>2.5+10</c:v>
                </c:pt>
                <c:pt idx="7">
                  <c:v>2.5+12.5</c:v>
                </c:pt>
                <c:pt idx="8">
                  <c:v>2.5+25</c:v>
                </c:pt>
                <c:pt idx="9">
                  <c:v>2.5+50</c:v>
                </c:pt>
                <c:pt idx="10">
                  <c:v>Art 10ng/ml</c:v>
                </c:pt>
                <c:pt idx="11">
                  <c:v>Art 5ng/ml</c:v>
                </c:pt>
                <c:pt idx="12">
                  <c:v>Art 1ng/ml</c:v>
                </c:pt>
                <c:pt idx="13">
                  <c:v>No Drug</c:v>
                </c:pt>
              </c:strCache>
            </c:strRef>
          </c:cat>
          <c:val>
            <c:numRef>
              <c:f>'3 diff isolates'!$M$3:$M$16</c:f>
              <c:numCache>
                <c:formatCode>General</c:formatCode>
                <c:ptCount val="14"/>
                <c:pt idx="0">
                  <c:v>-4.474097905760432</c:v>
                </c:pt>
                <c:pt idx="1">
                  <c:v>13.16246447950703</c:v>
                </c:pt>
                <c:pt idx="2">
                  <c:v>45.43893240310237</c:v>
                </c:pt>
                <c:pt idx="3">
                  <c:v>97.84484686620401</c:v>
                </c:pt>
                <c:pt idx="4">
                  <c:v>42.45575510733573</c:v>
                </c:pt>
                <c:pt idx="5">
                  <c:v>40.69121766997328</c:v>
                </c:pt>
                <c:pt idx="6">
                  <c:v>62.27057780340397</c:v>
                </c:pt>
                <c:pt idx="7">
                  <c:v>69.8902666687727</c:v>
                </c:pt>
                <c:pt idx="8">
                  <c:v>79.02642221079282</c:v>
                </c:pt>
                <c:pt idx="9">
                  <c:v>93.81937995905571</c:v>
                </c:pt>
                <c:pt idx="10">
                  <c:v>98.81285852011553</c:v>
                </c:pt>
                <c:pt idx="11">
                  <c:v>59.43274381536564</c:v>
                </c:pt>
                <c:pt idx="12">
                  <c:v>42.98106383961179</c:v>
                </c:pt>
                <c:pt idx="13">
                  <c:v>-4.518140739318E-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00257880"/>
        <c:axId val="2117129304"/>
      </c:barChart>
      <c:catAx>
        <c:axId val="2100257880"/>
        <c:scaling>
          <c:orientation val="minMax"/>
        </c:scaling>
        <c:delete val="0"/>
        <c:axPos val="b"/>
        <c:majorTickMark val="out"/>
        <c:minorTickMark val="none"/>
        <c:tickLblPos val="nextTo"/>
        <c:crossAx val="2117129304"/>
        <c:crosses val="autoZero"/>
        <c:auto val="1"/>
        <c:lblAlgn val="ctr"/>
        <c:lblOffset val="100"/>
        <c:noMultiLvlLbl val="0"/>
      </c:catAx>
      <c:valAx>
        <c:axId val="211712930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NF54 inhibition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0025788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3 diff isolates'!$S$3:$S$14</c:f>
                <c:numCache>
                  <c:formatCode>General</c:formatCode>
                  <c:ptCount val="12"/>
                  <c:pt idx="0">
                    <c:v>0.436091286105759</c:v>
                  </c:pt>
                  <c:pt idx="1">
                    <c:v>1.602196190344631</c:v>
                  </c:pt>
                  <c:pt idx="2">
                    <c:v>7.94229258065157</c:v>
                  </c:pt>
                  <c:pt idx="3">
                    <c:v>0.536727736745564</c:v>
                  </c:pt>
                  <c:pt idx="4">
                    <c:v>6.82749100853557</c:v>
                  </c:pt>
                  <c:pt idx="5">
                    <c:v>6.623431783729005</c:v>
                  </c:pt>
                  <c:pt idx="6">
                    <c:v>10.55380321730284</c:v>
                  </c:pt>
                  <c:pt idx="7">
                    <c:v>2.47997726842759</c:v>
                  </c:pt>
                  <c:pt idx="8">
                    <c:v>0.183701457517084</c:v>
                  </c:pt>
                  <c:pt idx="9">
                    <c:v>1.209234811655917</c:v>
                  </c:pt>
                  <c:pt idx="10">
                    <c:v>2.785872538345997</c:v>
                  </c:pt>
                  <c:pt idx="11">
                    <c:v>6.38961591025392E-6</c:v>
                  </c:pt>
                </c:numCache>
              </c:numRef>
            </c:plus>
            <c:minus>
              <c:numRef>
                <c:f>'3 diff isolates'!$S$3:$S$14</c:f>
                <c:numCache>
                  <c:formatCode>General</c:formatCode>
                  <c:ptCount val="12"/>
                  <c:pt idx="0">
                    <c:v>0.436091286105759</c:v>
                  </c:pt>
                  <c:pt idx="1">
                    <c:v>1.602196190344631</c:v>
                  </c:pt>
                  <c:pt idx="2">
                    <c:v>7.94229258065157</c:v>
                  </c:pt>
                  <c:pt idx="3">
                    <c:v>0.536727736745564</c:v>
                  </c:pt>
                  <c:pt idx="4">
                    <c:v>6.82749100853557</c:v>
                  </c:pt>
                  <c:pt idx="5">
                    <c:v>6.623431783729005</c:v>
                  </c:pt>
                  <c:pt idx="6">
                    <c:v>10.55380321730284</c:v>
                  </c:pt>
                  <c:pt idx="7">
                    <c:v>2.47997726842759</c:v>
                  </c:pt>
                  <c:pt idx="8">
                    <c:v>0.183701457517084</c:v>
                  </c:pt>
                  <c:pt idx="9">
                    <c:v>1.209234811655917</c:v>
                  </c:pt>
                  <c:pt idx="10">
                    <c:v>2.785872538345997</c:v>
                  </c:pt>
                  <c:pt idx="11">
                    <c:v>6.38961591025392E-6</c:v>
                  </c:pt>
                </c:numCache>
              </c:numRef>
            </c:minus>
          </c:errBars>
          <c:cat>
            <c:strRef>
              <c:f>'3 diff isolates'!$Q$3:$Q$14</c:f>
              <c:strCache>
                <c:ptCount val="12"/>
                <c:pt idx="0">
                  <c:v>0+5</c:v>
                </c:pt>
                <c:pt idx="1">
                  <c:v>0+10</c:v>
                </c:pt>
                <c:pt idx="2">
                  <c:v>0+25</c:v>
                </c:pt>
                <c:pt idx="3">
                  <c:v>0+50</c:v>
                </c:pt>
                <c:pt idx="4">
                  <c:v>1.25+0</c:v>
                </c:pt>
                <c:pt idx="5">
                  <c:v>1.25+5</c:v>
                </c:pt>
                <c:pt idx="6">
                  <c:v>1.25+12.5</c:v>
                </c:pt>
                <c:pt idx="7">
                  <c:v>1.25+25</c:v>
                </c:pt>
                <c:pt idx="8">
                  <c:v>Art 10ng/ml</c:v>
                </c:pt>
                <c:pt idx="9">
                  <c:v>Art 5ng/ml</c:v>
                </c:pt>
                <c:pt idx="10">
                  <c:v>Art 1ng/ml</c:v>
                </c:pt>
                <c:pt idx="11">
                  <c:v>No Drug</c:v>
                </c:pt>
              </c:strCache>
            </c:strRef>
          </c:cat>
          <c:val>
            <c:numRef>
              <c:f>'3 diff isolates'!$R$3:$R$14</c:f>
              <c:numCache>
                <c:formatCode>General</c:formatCode>
                <c:ptCount val="12"/>
                <c:pt idx="0">
                  <c:v>-4.474097905760432</c:v>
                </c:pt>
                <c:pt idx="1">
                  <c:v>13.16246447950703</c:v>
                </c:pt>
                <c:pt idx="2">
                  <c:v>45.43893240310237</c:v>
                </c:pt>
                <c:pt idx="3">
                  <c:v>97.84484686620401</c:v>
                </c:pt>
                <c:pt idx="4">
                  <c:v>22.6201943952007</c:v>
                </c:pt>
                <c:pt idx="5">
                  <c:v>25.150642052669</c:v>
                </c:pt>
                <c:pt idx="6">
                  <c:v>52.6892456105052</c:v>
                </c:pt>
                <c:pt idx="7">
                  <c:v>75.018629703172</c:v>
                </c:pt>
                <c:pt idx="8">
                  <c:v>98.81285852011553</c:v>
                </c:pt>
                <c:pt idx="9">
                  <c:v>59.43274381536564</c:v>
                </c:pt>
                <c:pt idx="10">
                  <c:v>42.98106383961179</c:v>
                </c:pt>
                <c:pt idx="11">
                  <c:v>-4.518140739318E-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62593992"/>
        <c:axId val="2091576488"/>
      </c:barChart>
      <c:catAx>
        <c:axId val="2062593992"/>
        <c:scaling>
          <c:orientation val="minMax"/>
        </c:scaling>
        <c:delete val="0"/>
        <c:axPos val="b"/>
        <c:majorTickMark val="out"/>
        <c:minorTickMark val="none"/>
        <c:tickLblPos val="nextTo"/>
        <c:crossAx val="2091576488"/>
        <c:crosses val="autoZero"/>
        <c:auto val="1"/>
        <c:lblAlgn val="ctr"/>
        <c:lblOffset val="100"/>
        <c:noMultiLvlLbl val="0"/>
      </c:catAx>
      <c:valAx>
        <c:axId val="209157648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NF54 inhibition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06259399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3 diff isolates'!$D$37:$D$48</c:f>
                <c:numCache>
                  <c:formatCode>General</c:formatCode>
                  <c:ptCount val="12"/>
                  <c:pt idx="0">
                    <c:v>1.661902020018567</c:v>
                  </c:pt>
                  <c:pt idx="1">
                    <c:v>0.0591424206412311</c:v>
                  </c:pt>
                  <c:pt idx="2">
                    <c:v>0.768851468335992</c:v>
                  </c:pt>
                  <c:pt idx="3">
                    <c:v>0.41399694448861</c:v>
                  </c:pt>
                  <c:pt idx="4">
                    <c:v>2.880235885227907</c:v>
                  </c:pt>
                  <c:pt idx="5">
                    <c:v>3.043592550583853</c:v>
                  </c:pt>
                  <c:pt idx="6">
                    <c:v>5.069946423680778</c:v>
                  </c:pt>
                  <c:pt idx="7">
                    <c:v>0.295712103206158</c:v>
                  </c:pt>
                  <c:pt idx="8">
                    <c:v>4.692512861898191</c:v>
                  </c:pt>
                  <c:pt idx="9">
                    <c:v>0.0295712103206218</c:v>
                  </c:pt>
                  <c:pt idx="10">
                    <c:v>0.0236569682564914</c:v>
                  </c:pt>
                  <c:pt idx="11">
                    <c:v>0.189255746051937</c:v>
                  </c:pt>
                </c:numCache>
              </c:numRef>
            </c:plus>
            <c:minus>
              <c:numRef>
                <c:f>'3 diff isolates'!$D$37:$D$48</c:f>
                <c:numCache>
                  <c:formatCode>General</c:formatCode>
                  <c:ptCount val="12"/>
                  <c:pt idx="0">
                    <c:v>1.661902020018567</c:v>
                  </c:pt>
                  <c:pt idx="1">
                    <c:v>0.0591424206412311</c:v>
                  </c:pt>
                  <c:pt idx="2">
                    <c:v>0.768851468335992</c:v>
                  </c:pt>
                  <c:pt idx="3">
                    <c:v>0.41399694448861</c:v>
                  </c:pt>
                  <c:pt idx="4">
                    <c:v>2.880235885227907</c:v>
                  </c:pt>
                  <c:pt idx="5">
                    <c:v>3.043592550583853</c:v>
                  </c:pt>
                  <c:pt idx="6">
                    <c:v>5.069946423680778</c:v>
                  </c:pt>
                  <c:pt idx="7">
                    <c:v>0.295712103206158</c:v>
                  </c:pt>
                  <c:pt idx="8">
                    <c:v>4.692512861898191</c:v>
                  </c:pt>
                  <c:pt idx="9">
                    <c:v>0.0295712103206218</c:v>
                  </c:pt>
                  <c:pt idx="10">
                    <c:v>0.0236569682564914</c:v>
                  </c:pt>
                  <c:pt idx="11">
                    <c:v>0.189255746051937</c:v>
                  </c:pt>
                </c:numCache>
              </c:numRef>
            </c:minus>
          </c:errBars>
          <c:cat>
            <c:strRef>
              <c:f>'3 diff isolates'!$B$37:$B$48</c:f>
              <c:strCache>
                <c:ptCount val="12"/>
                <c:pt idx="0">
                  <c:v>5+0</c:v>
                </c:pt>
                <c:pt idx="1">
                  <c:v>2.5+0</c:v>
                </c:pt>
                <c:pt idx="2">
                  <c:v>1.25+0</c:v>
                </c:pt>
                <c:pt idx="3">
                  <c:v>1.25+5</c:v>
                </c:pt>
                <c:pt idx="4">
                  <c:v>1.25+12.5</c:v>
                </c:pt>
                <c:pt idx="5">
                  <c:v>1.25+25</c:v>
                </c:pt>
                <c:pt idx="6">
                  <c:v>0+5</c:v>
                </c:pt>
                <c:pt idx="7">
                  <c:v>0+10</c:v>
                </c:pt>
                <c:pt idx="8">
                  <c:v>0+25</c:v>
                </c:pt>
                <c:pt idx="9">
                  <c:v>Art 10ng/ml</c:v>
                </c:pt>
                <c:pt idx="10">
                  <c:v>Art 2.5ng/ml</c:v>
                </c:pt>
                <c:pt idx="11">
                  <c:v>Art 1ng/ml</c:v>
                </c:pt>
              </c:strCache>
            </c:strRef>
          </c:cat>
          <c:val>
            <c:numRef>
              <c:f>'3 diff isolates'!$C$37:$C$48</c:f>
              <c:numCache>
                <c:formatCode>General</c:formatCode>
                <c:ptCount val="12"/>
                <c:pt idx="0">
                  <c:v>36.80578788892605</c:v>
                </c:pt>
                <c:pt idx="1">
                  <c:v>29.73402475744396</c:v>
                </c:pt>
                <c:pt idx="2">
                  <c:v>20.11542321846771</c:v>
                </c:pt>
                <c:pt idx="3">
                  <c:v>16.60254265640683</c:v>
                </c:pt>
                <c:pt idx="4">
                  <c:v>37.49163599866177</c:v>
                </c:pt>
                <c:pt idx="5">
                  <c:v>78.72476859596298</c:v>
                </c:pt>
                <c:pt idx="6">
                  <c:v>11.1520017843203</c:v>
                </c:pt>
                <c:pt idx="7">
                  <c:v>26.05386416861826</c:v>
                </c:pt>
                <c:pt idx="8">
                  <c:v>70.23809523809525</c:v>
                </c:pt>
                <c:pt idx="9">
                  <c:v>98.73285379725661</c:v>
                </c:pt>
                <c:pt idx="10">
                  <c:v>93.60990297758443</c:v>
                </c:pt>
                <c:pt idx="11">
                  <c:v>53.3372365339578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03886328"/>
        <c:axId val="2103520328"/>
      </c:barChart>
      <c:catAx>
        <c:axId val="2103886328"/>
        <c:scaling>
          <c:orientation val="minMax"/>
        </c:scaling>
        <c:delete val="0"/>
        <c:axPos val="b"/>
        <c:majorTickMark val="out"/>
        <c:minorTickMark val="none"/>
        <c:tickLblPos val="nextTo"/>
        <c:crossAx val="2103520328"/>
        <c:crosses val="autoZero"/>
        <c:auto val="1"/>
        <c:lblAlgn val="ctr"/>
        <c:lblOffset val="100"/>
        <c:noMultiLvlLbl val="0"/>
      </c:catAx>
      <c:valAx>
        <c:axId val="210352032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A8 inhibition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0388632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3 diff isolates'!$H$35:$H$48</c:f>
                <c:numCache>
                  <c:formatCode>General</c:formatCode>
                  <c:ptCount val="14"/>
                  <c:pt idx="0">
                    <c:v>1.661902020018567</c:v>
                  </c:pt>
                  <c:pt idx="1">
                    <c:v>0.0591424206412311</c:v>
                  </c:pt>
                  <c:pt idx="2">
                    <c:v>3.725972500397505</c:v>
                  </c:pt>
                  <c:pt idx="3">
                    <c:v>2.075898964507183</c:v>
                  </c:pt>
                  <c:pt idx="4">
                    <c:v>1.484474758094876</c:v>
                  </c:pt>
                  <c:pt idx="5">
                    <c:v>0.711005710734658</c:v>
                  </c:pt>
                  <c:pt idx="6">
                    <c:v>0.408082702424485</c:v>
                  </c:pt>
                  <c:pt idx="7">
                    <c:v>5.069946423680778</c:v>
                  </c:pt>
                  <c:pt idx="8">
                    <c:v>0.295712103206158</c:v>
                  </c:pt>
                  <c:pt idx="9">
                    <c:v>4.692512861898191</c:v>
                  </c:pt>
                  <c:pt idx="10">
                    <c:v>0.183341503987801</c:v>
                  </c:pt>
                  <c:pt idx="11">
                    <c:v>0.0295712103206218</c:v>
                  </c:pt>
                  <c:pt idx="12">
                    <c:v>0.0236569682564914</c:v>
                  </c:pt>
                  <c:pt idx="13">
                    <c:v>0.189255746051937</c:v>
                  </c:pt>
                </c:numCache>
              </c:numRef>
            </c:plus>
            <c:minus>
              <c:numRef>
                <c:f>'3 diff isolates'!$H$35:$H$48</c:f>
                <c:numCache>
                  <c:formatCode>General</c:formatCode>
                  <c:ptCount val="14"/>
                  <c:pt idx="0">
                    <c:v>1.661902020018567</c:v>
                  </c:pt>
                  <c:pt idx="1">
                    <c:v>0.0591424206412311</c:v>
                  </c:pt>
                  <c:pt idx="2">
                    <c:v>3.725972500397505</c:v>
                  </c:pt>
                  <c:pt idx="3">
                    <c:v>2.075898964507183</c:v>
                  </c:pt>
                  <c:pt idx="4">
                    <c:v>1.484474758094876</c:v>
                  </c:pt>
                  <c:pt idx="5">
                    <c:v>0.711005710734658</c:v>
                  </c:pt>
                  <c:pt idx="6">
                    <c:v>0.408082702424485</c:v>
                  </c:pt>
                  <c:pt idx="7">
                    <c:v>5.069946423680778</c:v>
                  </c:pt>
                  <c:pt idx="8">
                    <c:v>0.295712103206158</c:v>
                  </c:pt>
                  <c:pt idx="9">
                    <c:v>4.692512861898191</c:v>
                  </c:pt>
                  <c:pt idx="10">
                    <c:v>0.183341503987801</c:v>
                  </c:pt>
                  <c:pt idx="11">
                    <c:v>0.0295712103206218</c:v>
                  </c:pt>
                  <c:pt idx="12">
                    <c:v>0.0236569682564914</c:v>
                  </c:pt>
                  <c:pt idx="13">
                    <c:v>0.189255746051937</c:v>
                  </c:pt>
                </c:numCache>
              </c:numRef>
            </c:minus>
          </c:errBars>
          <c:cat>
            <c:strRef>
              <c:f>'3 diff isolates'!$F$35:$F$48</c:f>
              <c:strCache>
                <c:ptCount val="14"/>
                <c:pt idx="0">
                  <c:v>5+0</c:v>
                </c:pt>
                <c:pt idx="1">
                  <c:v>2.5+0</c:v>
                </c:pt>
                <c:pt idx="2">
                  <c:v>2.5+5</c:v>
                </c:pt>
                <c:pt idx="3">
                  <c:v>2.5+10</c:v>
                </c:pt>
                <c:pt idx="4">
                  <c:v>2.5+12.5</c:v>
                </c:pt>
                <c:pt idx="5">
                  <c:v>2.5+25</c:v>
                </c:pt>
                <c:pt idx="6">
                  <c:v>2.5+50</c:v>
                </c:pt>
                <c:pt idx="7">
                  <c:v>0+5</c:v>
                </c:pt>
                <c:pt idx="8">
                  <c:v>0+10</c:v>
                </c:pt>
                <c:pt idx="9">
                  <c:v>0+25</c:v>
                </c:pt>
                <c:pt idx="10">
                  <c:v>0+50</c:v>
                </c:pt>
                <c:pt idx="11">
                  <c:v>Art 10ng/ml</c:v>
                </c:pt>
                <c:pt idx="12">
                  <c:v>Art 2.5ng/ml</c:v>
                </c:pt>
                <c:pt idx="13">
                  <c:v>Art 1ng/ml</c:v>
                </c:pt>
              </c:strCache>
            </c:strRef>
          </c:cat>
          <c:val>
            <c:numRef>
              <c:f>'3 diff isolates'!$G$35:$G$48</c:f>
              <c:numCache>
                <c:formatCode>General</c:formatCode>
                <c:ptCount val="14"/>
                <c:pt idx="0">
                  <c:v>36.80578788892605</c:v>
                </c:pt>
                <c:pt idx="1">
                  <c:v>29.73402475744396</c:v>
                </c:pt>
                <c:pt idx="2">
                  <c:v>16.18434258949481</c:v>
                </c:pt>
                <c:pt idx="3">
                  <c:v>37.0399799263968</c:v>
                </c:pt>
                <c:pt idx="4">
                  <c:v>37.8094680495149</c:v>
                </c:pt>
                <c:pt idx="5">
                  <c:v>81.34548901527824</c:v>
                </c:pt>
                <c:pt idx="6">
                  <c:v>99.37688190030107</c:v>
                </c:pt>
                <c:pt idx="7">
                  <c:v>11.1520017843203</c:v>
                </c:pt>
                <c:pt idx="8">
                  <c:v>26.05386416861826</c:v>
                </c:pt>
                <c:pt idx="9">
                  <c:v>70.23809523809525</c:v>
                </c:pt>
                <c:pt idx="10">
                  <c:v>99.78671796587488</c:v>
                </c:pt>
                <c:pt idx="11">
                  <c:v>98.73285379725661</c:v>
                </c:pt>
                <c:pt idx="12">
                  <c:v>93.60990297758443</c:v>
                </c:pt>
                <c:pt idx="13">
                  <c:v>53.3372365339578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14073592"/>
        <c:axId val="2114343672"/>
      </c:barChart>
      <c:catAx>
        <c:axId val="2114073592"/>
        <c:scaling>
          <c:orientation val="minMax"/>
        </c:scaling>
        <c:delete val="0"/>
        <c:axPos val="b"/>
        <c:majorTickMark val="out"/>
        <c:minorTickMark val="none"/>
        <c:tickLblPos val="nextTo"/>
        <c:crossAx val="2114343672"/>
        <c:crosses val="autoZero"/>
        <c:auto val="1"/>
        <c:lblAlgn val="ctr"/>
        <c:lblOffset val="100"/>
        <c:noMultiLvlLbl val="0"/>
      </c:catAx>
      <c:valAx>
        <c:axId val="211434367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A8 inhibition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1407359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3 diff isolates'!$L$37:$L$48</c:f>
                <c:numCache>
                  <c:formatCode>General</c:formatCode>
                  <c:ptCount val="12"/>
                  <c:pt idx="0">
                    <c:v>2.069984722443047</c:v>
                  </c:pt>
                  <c:pt idx="1">
                    <c:v>1.661902020018567</c:v>
                  </c:pt>
                  <c:pt idx="2">
                    <c:v>0.57368148021993</c:v>
                  </c:pt>
                  <c:pt idx="3">
                    <c:v>0.603252690540547</c:v>
                  </c:pt>
                  <c:pt idx="4">
                    <c:v>0.502745363905946</c:v>
                  </c:pt>
                  <c:pt idx="5">
                    <c:v>5.069946423680778</c:v>
                  </c:pt>
                  <c:pt idx="6">
                    <c:v>0.295712103206158</c:v>
                  </c:pt>
                  <c:pt idx="7">
                    <c:v>4.692512861898191</c:v>
                  </c:pt>
                  <c:pt idx="8">
                    <c:v>0.183341503987801</c:v>
                  </c:pt>
                  <c:pt idx="9">
                    <c:v>0.0295712103206218</c:v>
                  </c:pt>
                  <c:pt idx="10">
                    <c:v>0.0236569682564914</c:v>
                  </c:pt>
                  <c:pt idx="11">
                    <c:v>0.189255746051937</c:v>
                  </c:pt>
                </c:numCache>
              </c:numRef>
            </c:plus>
            <c:minus>
              <c:numRef>
                <c:f>'3 diff isolates'!$L$37:$L$48</c:f>
                <c:numCache>
                  <c:formatCode>General</c:formatCode>
                  <c:ptCount val="12"/>
                  <c:pt idx="0">
                    <c:v>2.069984722443047</c:v>
                  </c:pt>
                  <c:pt idx="1">
                    <c:v>1.661902020018567</c:v>
                  </c:pt>
                  <c:pt idx="2">
                    <c:v>0.57368148021993</c:v>
                  </c:pt>
                  <c:pt idx="3">
                    <c:v>0.603252690540547</c:v>
                  </c:pt>
                  <c:pt idx="4">
                    <c:v>0.502745363905946</c:v>
                  </c:pt>
                  <c:pt idx="5">
                    <c:v>5.069946423680778</c:v>
                  </c:pt>
                  <c:pt idx="6">
                    <c:v>0.295712103206158</c:v>
                  </c:pt>
                  <c:pt idx="7">
                    <c:v>4.692512861898191</c:v>
                  </c:pt>
                  <c:pt idx="8">
                    <c:v>0.183341503987801</c:v>
                  </c:pt>
                  <c:pt idx="9">
                    <c:v>0.0295712103206218</c:v>
                  </c:pt>
                  <c:pt idx="10">
                    <c:v>0.0236569682564914</c:v>
                  </c:pt>
                  <c:pt idx="11">
                    <c:v>0.189255746051937</c:v>
                  </c:pt>
                </c:numCache>
              </c:numRef>
            </c:minus>
          </c:errBars>
          <c:cat>
            <c:strRef>
              <c:f>'3 diff isolates'!$J$37:$J$48</c:f>
              <c:strCache>
                <c:ptCount val="12"/>
                <c:pt idx="0">
                  <c:v>10+0</c:v>
                </c:pt>
                <c:pt idx="1">
                  <c:v>5+0</c:v>
                </c:pt>
                <c:pt idx="2">
                  <c:v>5+10</c:v>
                </c:pt>
                <c:pt idx="3">
                  <c:v>5+25</c:v>
                </c:pt>
                <c:pt idx="4">
                  <c:v>5+50</c:v>
                </c:pt>
                <c:pt idx="5">
                  <c:v>0+5</c:v>
                </c:pt>
                <c:pt idx="6">
                  <c:v>0+10</c:v>
                </c:pt>
                <c:pt idx="7">
                  <c:v>0+25</c:v>
                </c:pt>
                <c:pt idx="8">
                  <c:v>0+50</c:v>
                </c:pt>
                <c:pt idx="9">
                  <c:v>Art 10ng/ml</c:v>
                </c:pt>
                <c:pt idx="10">
                  <c:v>Art 2.5ng/ml</c:v>
                </c:pt>
                <c:pt idx="11">
                  <c:v>Art 1ng/ml</c:v>
                </c:pt>
              </c:strCache>
            </c:strRef>
          </c:cat>
          <c:val>
            <c:numRef>
              <c:f>'3 diff isolates'!$K$37:$K$48</c:f>
              <c:numCache>
                <c:formatCode>General</c:formatCode>
                <c:ptCount val="12"/>
                <c:pt idx="0">
                  <c:v>79.13181666109066</c:v>
                </c:pt>
                <c:pt idx="1">
                  <c:v>36.80578788892605</c:v>
                </c:pt>
                <c:pt idx="2">
                  <c:v>55.4909668785547</c:v>
                </c:pt>
                <c:pt idx="3">
                  <c:v>86.81833389093339</c:v>
                </c:pt>
                <c:pt idx="4">
                  <c:v>100.4014720642355</c:v>
                </c:pt>
                <c:pt idx="5">
                  <c:v>11.1520017843203</c:v>
                </c:pt>
                <c:pt idx="6">
                  <c:v>26.05386416861826</c:v>
                </c:pt>
                <c:pt idx="7">
                  <c:v>70.23809523809525</c:v>
                </c:pt>
                <c:pt idx="8">
                  <c:v>99.78671796587488</c:v>
                </c:pt>
                <c:pt idx="9">
                  <c:v>98.73285379725661</c:v>
                </c:pt>
                <c:pt idx="10">
                  <c:v>93.60990297758443</c:v>
                </c:pt>
                <c:pt idx="11">
                  <c:v>53.3372365339578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00468728"/>
        <c:axId val="2114950552"/>
      </c:barChart>
      <c:catAx>
        <c:axId val="2100468728"/>
        <c:scaling>
          <c:orientation val="minMax"/>
        </c:scaling>
        <c:delete val="0"/>
        <c:axPos val="b"/>
        <c:majorTickMark val="out"/>
        <c:minorTickMark val="none"/>
        <c:tickLblPos val="nextTo"/>
        <c:crossAx val="2114950552"/>
        <c:crosses val="autoZero"/>
        <c:auto val="1"/>
        <c:lblAlgn val="ctr"/>
        <c:lblOffset val="100"/>
        <c:noMultiLvlLbl val="0"/>
      </c:catAx>
      <c:valAx>
        <c:axId val="211495055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A8 inhibition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0046872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3 diff isolates'!$D$60:$D$71</c:f>
                <c:numCache>
                  <c:formatCode>General</c:formatCode>
                  <c:ptCount val="12"/>
                  <c:pt idx="0">
                    <c:v>1.516240993726658</c:v>
                  </c:pt>
                  <c:pt idx="1">
                    <c:v>0.247983340095473</c:v>
                  </c:pt>
                  <c:pt idx="2">
                    <c:v>0.389688105864327</c:v>
                  </c:pt>
                  <c:pt idx="3">
                    <c:v>2.912032936549808</c:v>
                  </c:pt>
                  <c:pt idx="4">
                    <c:v>0.949421930651268</c:v>
                  </c:pt>
                  <c:pt idx="5">
                    <c:v>0.337770978492892</c:v>
                  </c:pt>
                  <c:pt idx="6">
                    <c:v>2.600282451858345</c:v>
                  </c:pt>
                  <c:pt idx="7">
                    <c:v>0.425114297306549</c:v>
                  </c:pt>
                  <c:pt idx="8">
                    <c:v>0.134619527480404</c:v>
                  </c:pt>
                  <c:pt idx="9">
                    <c:v>1.027359551824137</c:v>
                  </c:pt>
                  <c:pt idx="10">
                    <c:v>0.0354261914422248</c:v>
                  </c:pt>
                  <c:pt idx="11">
                    <c:v>0.814278543242889</c:v>
                  </c:pt>
                </c:numCache>
              </c:numRef>
            </c:plus>
            <c:minus>
              <c:numRef>
                <c:f>'3 diff isolates'!$D$60:$D$71</c:f>
                <c:numCache>
                  <c:formatCode>General</c:formatCode>
                  <c:ptCount val="12"/>
                  <c:pt idx="0">
                    <c:v>1.516240993726658</c:v>
                  </c:pt>
                  <c:pt idx="1">
                    <c:v>0.247983340095473</c:v>
                  </c:pt>
                  <c:pt idx="2">
                    <c:v>0.389688105864327</c:v>
                  </c:pt>
                  <c:pt idx="3">
                    <c:v>2.912032936549808</c:v>
                  </c:pt>
                  <c:pt idx="4">
                    <c:v>0.949421930651268</c:v>
                  </c:pt>
                  <c:pt idx="5">
                    <c:v>0.337770978492892</c:v>
                  </c:pt>
                  <c:pt idx="6">
                    <c:v>2.600282451858345</c:v>
                  </c:pt>
                  <c:pt idx="7">
                    <c:v>0.425114297306549</c:v>
                  </c:pt>
                  <c:pt idx="8">
                    <c:v>0.134619527480404</c:v>
                  </c:pt>
                  <c:pt idx="9">
                    <c:v>1.027359551824137</c:v>
                  </c:pt>
                  <c:pt idx="10">
                    <c:v>0.0354261914422248</c:v>
                  </c:pt>
                  <c:pt idx="11">
                    <c:v>0.814278543242889</c:v>
                  </c:pt>
                </c:numCache>
              </c:numRef>
            </c:minus>
          </c:errBars>
          <c:cat>
            <c:strRef>
              <c:f>'3 diff isolates'!$B$60:$B$71</c:f>
              <c:strCache>
                <c:ptCount val="12"/>
                <c:pt idx="0">
                  <c:v>10+0</c:v>
                </c:pt>
                <c:pt idx="1">
                  <c:v>5+0</c:v>
                </c:pt>
                <c:pt idx="2">
                  <c:v>1.25+0</c:v>
                </c:pt>
                <c:pt idx="3">
                  <c:v>1.25+5</c:v>
                </c:pt>
                <c:pt idx="4">
                  <c:v>1.25+12.5</c:v>
                </c:pt>
                <c:pt idx="5">
                  <c:v>1.25+25</c:v>
                </c:pt>
                <c:pt idx="6">
                  <c:v>0+5</c:v>
                </c:pt>
                <c:pt idx="7">
                  <c:v>0+10</c:v>
                </c:pt>
                <c:pt idx="8">
                  <c:v>0+25</c:v>
                </c:pt>
                <c:pt idx="9">
                  <c:v>Art 10ng/ml</c:v>
                </c:pt>
                <c:pt idx="10">
                  <c:v>Art 2.5ng/ml</c:v>
                </c:pt>
                <c:pt idx="11">
                  <c:v>Art 1ng/ml</c:v>
                </c:pt>
              </c:strCache>
            </c:strRef>
          </c:cat>
          <c:val>
            <c:numRef>
              <c:f>'3 diff isolates'!$C$60:$C$71</c:f>
              <c:numCache>
                <c:formatCode>General</c:formatCode>
                <c:ptCount val="12"/>
                <c:pt idx="0">
                  <c:v>70.6613226452906</c:v>
                </c:pt>
                <c:pt idx="1">
                  <c:v>31.75851703406812</c:v>
                </c:pt>
                <c:pt idx="2">
                  <c:v>21.51803607214428</c:v>
                </c:pt>
                <c:pt idx="3">
                  <c:v>21.2374749498998</c:v>
                </c:pt>
                <c:pt idx="4">
                  <c:v>40.52104208416833</c:v>
                </c:pt>
                <c:pt idx="5">
                  <c:v>71.62992651970605</c:v>
                </c:pt>
                <c:pt idx="6">
                  <c:v>23.40180360721443</c:v>
                </c:pt>
                <c:pt idx="7">
                  <c:v>13.62725450901804</c:v>
                </c:pt>
                <c:pt idx="8">
                  <c:v>65.78657314629258</c:v>
                </c:pt>
                <c:pt idx="9">
                  <c:v>80.53607214428854</c:v>
                </c:pt>
                <c:pt idx="10">
                  <c:v>74.0230460921843</c:v>
                </c:pt>
                <c:pt idx="11">
                  <c:v>42.575150300601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8380248"/>
        <c:axId val="2128013640"/>
      </c:barChart>
      <c:catAx>
        <c:axId val="2128380248"/>
        <c:scaling>
          <c:orientation val="minMax"/>
        </c:scaling>
        <c:delete val="0"/>
        <c:axPos val="b"/>
        <c:majorTickMark val="out"/>
        <c:minorTickMark val="none"/>
        <c:tickLblPos val="nextTo"/>
        <c:crossAx val="2128013640"/>
        <c:crosses val="autoZero"/>
        <c:auto val="1"/>
        <c:lblAlgn val="ctr"/>
        <c:lblOffset val="100"/>
        <c:noMultiLvlLbl val="0"/>
      </c:catAx>
      <c:valAx>
        <c:axId val="212801364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am_WT inhibition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2838024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3 diff isolates'!$H$59:$H$73</c:f>
                <c:numCache>
                  <c:formatCode>General</c:formatCode>
                  <c:ptCount val="15"/>
                  <c:pt idx="0">
                    <c:v>1.516240993726658</c:v>
                  </c:pt>
                  <c:pt idx="1">
                    <c:v>0.247983340095473</c:v>
                  </c:pt>
                  <c:pt idx="2">
                    <c:v>0.921080977497495</c:v>
                  </c:pt>
                  <c:pt idx="3">
                    <c:v>2.25310577572468</c:v>
                  </c:pt>
                  <c:pt idx="4">
                    <c:v>1.558752423457328</c:v>
                  </c:pt>
                  <c:pt idx="5">
                    <c:v>0.602245254517595</c:v>
                  </c:pt>
                  <c:pt idx="6">
                    <c:v>0.354261914422107</c:v>
                  </c:pt>
                  <c:pt idx="7">
                    <c:v>0.227243669915488</c:v>
                  </c:pt>
                  <c:pt idx="8">
                    <c:v>2.600282451858345</c:v>
                  </c:pt>
                  <c:pt idx="9">
                    <c:v>0.425114297306549</c:v>
                  </c:pt>
                  <c:pt idx="10">
                    <c:v>0.134619527480404</c:v>
                  </c:pt>
                  <c:pt idx="11">
                    <c:v>0.887890898471969</c:v>
                  </c:pt>
                  <c:pt idx="12">
                    <c:v>1.027359551824137</c:v>
                  </c:pt>
                  <c:pt idx="13">
                    <c:v>0.0354261914422248</c:v>
                  </c:pt>
                  <c:pt idx="14">
                    <c:v>0.814278543242889</c:v>
                  </c:pt>
                </c:numCache>
              </c:numRef>
            </c:plus>
            <c:minus>
              <c:numRef>
                <c:f>'3 diff isolates'!$H$59:$H$73</c:f>
                <c:numCache>
                  <c:formatCode>General</c:formatCode>
                  <c:ptCount val="15"/>
                  <c:pt idx="0">
                    <c:v>1.516240993726658</c:v>
                  </c:pt>
                  <c:pt idx="1">
                    <c:v>0.247983340095473</c:v>
                  </c:pt>
                  <c:pt idx="2">
                    <c:v>0.921080977497495</c:v>
                  </c:pt>
                  <c:pt idx="3">
                    <c:v>2.25310577572468</c:v>
                  </c:pt>
                  <c:pt idx="4">
                    <c:v>1.558752423457328</c:v>
                  </c:pt>
                  <c:pt idx="5">
                    <c:v>0.602245254517595</c:v>
                  </c:pt>
                  <c:pt idx="6">
                    <c:v>0.354261914422107</c:v>
                  </c:pt>
                  <c:pt idx="7">
                    <c:v>0.227243669915488</c:v>
                  </c:pt>
                  <c:pt idx="8">
                    <c:v>2.600282451858345</c:v>
                  </c:pt>
                  <c:pt idx="9">
                    <c:v>0.425114297306549</c:v>
                  </c:pt>
                  <c:pt idx="10">
                    <c:v>0.134619527480404</c:v>
                  </c:pt>
                  <c:pt idx="11">
                    <c:v>0.887890898471969</c:v>
                  </c:pt>
                  <c:pt idx="12">
                    <c:v>1.027359551824137</c:v>
                  </c:pt>
                  <c:pt idx="13">
                    <c:v>0.0354261914422248</c:v>
                  </c:pt>
                  <c:pt idx="14">
                    <c:v>0.814278543242889</c:v>
                  </c:pt>
                </c:numCache>
              </c:numRef>
            </c:minus>
          </c:errBars>
          <c:cat>
            <c:strRef>
              <c:f>'3 diff isolates'!$F$59:$F$73</c:f>
              <c:strCache>
                <c:ptCount val="15"/>
                <c:pt idx="0">
                  <c:v>10+0</c:v>
                </c:pt>
                <c:pt idx="1">
                  <c:v>5+0</c:v>
                </c:pt>
                <c:pt idx="2">
                  <c:v>2.5+0</c:v>
                </c:pt>
                <c:pt idx="3">
                  <c:v>2.5+5</c:v>
                </c:pt>
                <c:pt idx="4">
                  <c:v>2.5+10</c:v>
                </c:pt>
                <c:pt idx="5">
                  <c:v>2.5+12.5</c:v>
                </c:pt>
                <c:pt idx="6">
                  <c:v>2.5+25</c:v>
                </c:pt>
                <c:pt idx="7">
                  <c:v>2.5+50</c:v>
                </c:pt>
                <c:pt idx="8">
                  <c:v>0+5</c:v>
                </c:pt>
                <c:pt idx="9">
                  <c:v>0+10</c:v>
                </c:pt>
                <c:pt idx="10">
                  <c:v>0+25</c:v>
                </c:pt>
                <c:pt idx="11">
                  <c:v>0+50</c:v>
                </c:pt>
                <c:pt idx="12">
                  <c:v>Art 10ng/ml</c:v>
                </c:pt>
                <c:pt idx="13">
                  <c:v>Art 2.5ng/ml</c:v>
                </c:pt>
                <c:pt idx="14">
                  <c:v>Art 1ng/ml</c:v>
                </c:pt>
              </c:strCache>
            </c:strRef>
          </c:cat>
          <c:val>
            <c:numRef>
              <c:f>'3 diff isolates'!$G$59:$G$73</c:f>
              <c:numCache>
                <c:formatCode>General</c:formatCode>
                <c:ptCount val="15"/>
                <c:pt idx="0">
                  <c:v>70.6613226452906</c:v>
                </c:pt>
                <c:pt idx="1">
                  <c:v>31.75851703406812</c:v>
                </c:pt>
                <c:pt idx="2">
                  <c:v>11.87374749498998</c:v>
                </c:pt>
                <c:pt idx="3">
                  <c:v>18.62725450901804</c:v>
                </c:pt>
                <c:pt idx="4">
                  <c:v>35.85170340681359</c:v>
                </c:pt>
                <c:pt idx="5">
                  <c:v>55.00501002004007</c:v>
                </c:pt>
                <c:pt idx="6">
                  <c:v>72.64529058116232</c:v>
                </c:pt>
                <c:pt idx="7">
                  <c:v>78.65397461589845</c:v>
                </c:pt>
                <c:pt idx="8">
                  <c:v>23.40180360721443</c:v>
                </c:pt>
                <c:pt idx="9">
                  <c:v>13.62725450901804</c:v>
                </c:pt>
                <c:pt idx="10">
                  <c:v>65.78657314629258</c:v>
                </c:pt>
                <c:pt idx="11">
                  <c:v>81.4929859719439</c:v>
                </c:pt>
                <c:pt idx="12">
                  <c:v>80.53607214428854</c:v>
                </c:pt>
                <c:pt idx="13">
                  <c:v>74.0230460921843</c:v>
                </c:pt>
                <c:pt idx="14">
                  <c:v>42.575150300601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03229000"/>
        <c:axId val="2124465160"/>
      </c:barChart>
      <c:catAx>
        <c:axId val="2103229000"/>
        <c:scaling>
          <c:orientation val="minMax"/>
        </c:scaling>
        <c:delete val="0"/>
        <c:axPos val="b"/>
        <c:majorTickMark val="out"/>
        <c:minorTickMark val="none"/>
        <c:tickLblPos val="nextTo"/>
        <c:crossAx val="2124465160"/>
        <c:crosses val="autoZero"/>
        <c:auto val="1"/>
        <c:lblAlgn val="ctr"/>
        <c:lblOffset val="100"/>
        <c:noMultiLvlLbl val="0"/>
      </c:catAx>
      <c:valAx>
        <c:axId val="212446516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am_WT inhibition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0322900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363B8-F18D-9548-936F-FDD8EFC0F0B9}" type="datetimeFigureOut">
              <a:rPr lang="en-US" smtClean="0"/>
              <a:t>7/2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F2A7-DA7A-E645-8BAD-E0230E0538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0943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363B8-F18D-9548-936F-FDD8EFC0F0B9}" type="datetimeFigureOut">
              <a:rPr lang="en-US" smtClean="0"/>
              <a:t>7/2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F2A7-DA7A-E645-8BAD-E0230E0538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0029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363B8-F18D-9548-936F-FDD8EFC0F0B9}" type="datetimeFigureOut">
              <a:rPr lang="en-US" smtClean="0"/>
              <a:t>7/2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F2A7-DA7A-E645-8BAD-E0230E0538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5161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363B8-F18D-9548-936F-FDD8EFC0F0B9}" type="datetimeFigureOut">
              <a:rPr lang="en-US" smtClean="0"/>
              <a:t>7/2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F2A7-DA7A-E645-8BAD-E0230E0538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52964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363B8-F18D-9548-936F-FDD8EFC0F0B9}" type="datetimeFigureOut">
              <a:rPr lang="en-US" smtClean="0"/>
              <a:t>7/2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F2A7-DA7A-E645-8BAD-E0230E0538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2604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363B8-F18D-9548-936F-FDD8EFC0F0B9}" type="datetimeFigureOut">
              <a:rPr lang="en-US" smtClean="0"/>
              <a:t>7/2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F2A7-DA7A-E645-8BAD-E0230E0538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8130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363B8-F18D-9548-936F-FDD8EFC0F0B9}" type="datetimeFigureOut">
              <a:rPr lang="en-US" smtClean="0"/>
              <a:t>7/25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F2A7-DA7A-E645-8BAD-E0230E0538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96187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363B8-F18D-9548-936F-FDD8EFC0F0B9}" type="datetimeFigureOut">
              <a:rPr lang="en-US" smtClean="0"/>
              <a:t>7/25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F2A7-DA7A-E645-8BAD-E0230E0538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94322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363B8-F18D-9548-936F-FDD8EFC0F0B9}" type="datetimeFigureOut">
              <a:rPr lang="en-US" smtClean="0"/>
              <a:t>7/25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F2A7-DA7A-E645-8BAD-E0230E0538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48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363B8-F18D-9548-936F-FDD8EFC0F0B9}" type="datetimeFigureOut">
              <a:rPr lang="en-US" smtClean="0"/>
              <a:t>7/2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F2A7-DA7A-E645-8BAD-E0230E0538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3900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5363B8-F18D-9548-936F-FDD8EFC0F0B9}" type="datetimeFigureOut">
              <a:rPr lang="en-US" smtClean="0"/>
              <a:t>7/2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F2A7-DA7A-E645-8BAD-E0230E0538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72324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5363B8-F18D-9548-936F-FDD8EFC0F0B9}" type="datetimeFigureOut">
              <a:rPr lang="en-US" smtClean="0"/>
              <a:t>7/2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9CF2A7-DA7A-E645-8BAD-E0230E0538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0047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4" Type="http://schemas.openxmlformats.org/officeDocument/2006/relationships/chart" Target="../charts/chart7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5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4" Type="http://schemas.openxmlformats.org/officeDocument/2006/relationships/chart" Target="../charts/chart10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4266" y="1234546"/>
            <a:ext cx="4000500" cy="3406775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Rectangle 6"/>
          <p:cNvSpPr/>
          <p:nvPr/>
        </p:nvSpPr>
        <p:spPr>
          <a:xfrm>
            <a:off x="5029200" y="1325701"/>
            <a:ext cx="3979333" cy="43396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/>
              <a:t>Plate </a:t>
            </a:r>
            <a:r>
              <a:rPr lang="en-US" sz="1200" dirty="0"/>
              <a:t>I </a:t>
            </a:r>
            <a:r>
              <a:rPr lang="en-US" sz="1200" b="1" dirty="0"/>
              <a:t>(I)</a:t>
            </a:r>
            <a:endParaRPr lang="en-US" sz="1200" dirty="0"/>
          </a:p>
          <a:p>
            <a:r>
              <a:rPr lang="en-US" sz="1200" dirty="0"/>
              <a:t>A volume of 25 μl of different concentrations of each herbal extract; 100, 40, 20 and 10 μg/ml of </a:t>
            </a:r>
            <a:r>
              <a:rPr lang="en-US" sz="1200" i="1" dirty="0"/>
              <a:t>A. cordifolia </a:t>
            </a:r>
            <a:r>
              <a:rPr lang="en-US" sz="1200" dirty="0"/>
              <a:t>(written on the left of the + sign) and 40, 20, 10 and 5 μg/ml of </a:t>
            </a:r>
            <a:r>
              <a:rPr lang="en-US" sz="1200" i="1" dirty="0"/>
              <a:t>M. </a:t>
            </a:r>
            <a:r>
              <a:rPr lang="en-US" sz="1200" i="1" dirty="0" err="1"/>
              <a:t>indica</a:t>
            </a:r>
            <a:r>
              <a:rPr lang="en-US" sz="1200" dirty="0"/>
              <a:t> (written on the right of the + sign) was placed in each well.  Final volume for both extracts and culture in each well was 50 µL.  </a:t>
            </a:r>
          </a:p>
          <a:p>
            <a:r>
              <a:rPr lang="en-US" sz="1200" dirty="0"/>
              <a:t>A volume of 50 µL of artesunate at concentrations ranging from </a:t>
            </a:r>
            <a:r>
              <a:rPr lang="en-US" sz="1200" dirty="0"/>
              <a:t>2</a:t>
            </a:r>
            <a:r>
              <a:rPr lang="en-US" sz="1200" dirty="0" smtClean="0"/>
              <a:t>0 </a:t>
            </a:r>
            <a:r>
              <a:rPr lang="en-US" sz="1200" dirty="0"/>
              <a:t>– 2 ng/mL was used as the positive control. 50 µL of culture set at a range of parasitaemia (1-0%)  were also plated without treatment to serve as the negative controls. Finally 50 µL of parasite culture set at 4% </a:t>
            </a:r>
            <a:r>
              <a:rPr lang="en-US" sz="1200" dirty="0" err="1"/>
              <a:t>haematocrit</a:t>
            </a:r>
            <a:r>
              <a:rPr lang="en-US" sz="1200" dirty="0"/>
              <a:t> and 1% parasitaemia was added to each wells.</a:t>
            </a:r>
          </a:p>
          <a:p>
            <a:r>
              <a:rPr lang="en-US" sz="1200" dirty="0"/>
              <a:t>A standard curve was drawn using the readings from the untreated parasite cultures. final</a:t>
            </a:r>
          </a:p>
          <a:p>
            <a:r>
              <a:rPr lang="en-US" sz="1200" dirty="0"/>
              <a:t> </a:t>
            </a:r>
          </a:p>
          <a:p>
            <a:r>
              <a:rPr lang="en-US" sz="1200" dirty="0"/>
              <a:t>Plate II  </a:t>
            </a:r>
            <a:r>
              <a:rPr lang="en-US" sz="1200" b="1" dirty="0"/>
              <a:t>(II)</a:t>
            </a:r>
            <a:endParaRPr lang="en-US" sz="1200" dirty="0"/>
          </a:p>
          <a:p>
            <a:r>
              <a:rPr lang="en-US" sz="1200" dirty="0"/>
              <a:t>The second plate was set up similar to the first except the concentrations of </a:t>
            </a:r>
            <a:r>
              <a:rPr lang="en-US" sz="1200" i="1" dirty="0"/>
              <a:t>the </a:t>
            </a:r>
            <a:r>
              <a:rPr lang="en-US" sz="1200" dirty="0"/>
              <a:t>herbal extracts and artesunate were different (as stated in the diagram); 40, 20, 10 and 5 μg/ml of </a:t>
            </a:r>
            <a:r>
              <a:rPr lang="en-US" sz="1200" i="1" dirty="0"/>
              <a:t>A. cordifolia </a:t>
            </a:r>
            <a:r>
              <a:rPr lang="en-US" sz="1200" dirty="0"/>
              <a:t>(written on the left of the + sign) and 200, 100, 50, 40,  and 20 μg/ml of </a:t>
            </a:r>
            <a:r>
              <a:rPr lang="en-US" sz="1200" i="1" dirty="0"/>
              <a:t>A. cordifolia </a:t>
            </a:r>
            <a:r>
              <a:rPr lang="en-US" sz="1200" dirty="0"/>
              <a:t>(written on the right of the + sign</a:t>
            </a:r>
            <a:r>
              <a:rPr lang="en-US" sz="1200" dirty="0" smtClean="0"/>
              <a:t>) and artesunate 400 </a:t>
            </a:r>
            <a:r>
              <a:rPr lang="en-US" sz="1200" dirty="0"/>
              <a:t>– </a:t>
            </a:r>
            <a:r>
              <a:rPr lang="en-US" sz="1200" dirty="0" smtClean="0"/>
              <a:t>50 </a:t>
            </a:r>
            <a:r>
              <a:rPr lang="en-US" sz="1200" dirty="0"/>
              <a:t>ng/mL </a:t>
            </a:r>
            <a:endParaRPr lang="en-US" sz="1200" dirty="0"/>
          </a:p>
        </p:txBody>
      </p:sp>
      <p:sp>
        <p:nvSpPr>
          <p:cNvPr id="8" name="Rectangle 7"/>
          <p:cNvSpPr/>
          <p:nvPr/>
        </p:nvSpPr>
        <p:spPr>
          <a:xfrm>
            <a:off x="694266" y="4839786"/>
            <a:ext cx="40005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The numbers in the tables are the final concentrations in μg/ml of the herbal extracts and ng/ml for artesunate (Art). Para, parasitaemia obtained by seeding untreated infected red blood cells into the wells. RPMI, </a:t>
            </a:r>
            <a:r>
              <a:rPr lang="en-US" sz="1200" dirty="0" err="1"/>
              <a:t>Rosewell</a:t>
            </a:r>
            <a:r>
              <a:rPr lang="en-US" sz="1200" dirty="0"/>
              <a:t> Parks Memorial Institute (RPMI) 1640 medium</a:t>
            </a:r>
            <a:r>
              <a:rPr lang="en-US" sz="1200" dirty="0" smtClean="0"/>
              <a:t>.</a:t>
            </a:r>
            <a:endParaRPr lang="en-US" sz="1200" dirty="0"/>
          </a:p>
        </p:txBody>
      </p:sp>
      <p:sp>
        <p:nvSpPr>
          <p:cNvPr id="9" name="Rectangle 8"/>
          <p:cNvSpPr/>
          <p:nvPr/>
        </p:nvSpPr>
        <p:spPr>
          <a:xfrm>
            <a:off x="474133" y="294901"/>
            <a:ext cx="509693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Additional file Figure S1. Drug assay plate set up</a:t>
            </a:r>
          </a:p>
        </p:txBody>
      </p:sp>
    </p:spTree>
    <p:extLst>
      <p:ext uri="{BB962C8B-B14F-4D97-AF65-F5344CB8AC3E}">
        <p14:creationId xmlns:p14="http://schemas.microsoft.com/office/powerpoint/2010/main" val="15418227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6534775"/>
              </p:ext>
            </p:extLst>
          </p:nvPr>
        </p:nvGraphicFramePr>
        <p:xfrm>
          <a:off x="355924" y="811402"/>
          <a:ext cx="351155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67035398"/>
              </p:ext>
            </p:extLst>
          </p:nvPr>
        </p:nvGraphicFramePr>
        <p:xfrm>
          <a:off x="4007174" y="811402"/>
          <a:ext cx="37338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84322690"/>
              </p:ext>
            </p:extLst>
          </p:nvPr>
        </p:nvGraphicFramePr>
        <p:xfrm>
          <a:off x="355924" y="3296545"/>
          <a:ext cx="365125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26493298"/>
              </p:ext>
            </p:extLst>
          </p:nvPr>
        </p:nvGraphicFramePr>
        <p:xfrm>
          <a:off x="4007174" y="3296545"/>
          <a:ext cx="370205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" name="Rectangle 1"/>
          <p:cNvSpPr/>
          <p:nvPr/>
        </p:nvSpPr>
        <p:spPr>
          <a:xfrm>
            <a:off x="355924" y="114028"/>
            <a:ext cx="773853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Additional file Figure </a:t>
            </a:r>
            <a:r>
              <a:rPr lang="en-US" dirty="0" smtClean="0"/>
              <a:t>S2a. </a:t>
            </a:r>
            <a:r>
              <a:rPr lang="en-US" dirty="0"/>
              <a:t>Graphical representation of combination growth inhibition </a:t>
            </a:r>
            <a:r>
              <a:rPr lang="en-US" dirty="0" smtClean="0"/>
              <a:t>data for NF54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355923" y="6099137"/>
            <a:ext cx="85168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The concentration of A</a:t>
            </a:r>
            <a:r>
              <a:rPr lang="en-US" i="1" dirty="0"/>
              <a:t>. cordifolia </a:t>
            </a:r>
            <a:r>
              <a:rPr lang="en-US" dirty="0" smtClean="0"/>
              <a:t>is written </a:t>
            </a:r>
            <a:r>
              <a:rPr lang="en-US" dirty="0"/>
              <a:t>on the left of the + </a:t>
            </a:r>
            <a:r>
              <a:rPr lang="en-US" dirty="0" smtClean="0"/>
              <a:t>sign and the concentration of </a:t>
            </a:r>
            <a:r>
              <a:rPr lang="en-US" i="1" dirty="0"/>
              <a:t>M. </a:t>
            </a:r>
            <a:r>
              <a:rPr lang="en-US" i="1" dirty="0" err="1"/>
              <a:t>indica</a:t>
            </a:r>
            <a:r>
              <a:rPr lang="en-US" dirty="0"/>
              <a:t> </a:t>
            </a:r>
            <a:r>
              <a:rPr lang="en-US" dirty="0" smtClean="0"/>
              <a:t>is written </a:t>
            </a:r>
            <a:r>
              <a:rPr lang="en-US" dirty="0"/>
              <a:t>on the right of the + </a:t>
            </a:r>
            <a:r>
              <a:rPr lang="en-US" dirty="0" smtClean="0"/>
              <a:t>sign. Concentrations of the extracts are </a:t>
            </a:r>
            <a:r>
              <a:rPr lang="en-US" dirty="0"/>
              <a:t>μg/ml </a:t>
            </a:r>
          </a:p>
        </p:txBody>
      </p:sp>
    </p:spTree>
    <p:extLst>
      <p:ext uri="{BB962C8B-B14F-4D97-AF65-F5344CB8AC3E}">
        <p14:creationId xmlns:p14="http://schemas.microsoft.com/office/powerpoint/2010/main" val="25014079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40446045"/>
              </p:ext>
            </p:extLst>
          </p:nvPr>
        </p:nvGraphicFramePr>
        <p:xfrm>
          <a:off x="0" y="1006075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59725251"/>
              </p:ext>
            </p:extLst>
          </p:nvPr>
        </p:nvGraphicFramePr>
        <p:xfrm>
          <a:off x="2095207" y="3437274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20348227"/>
              </p:ext>
            </p:extLst>
          </p:nvPr>
        </p:nvGraphicFramePr>
        <p:xfrm>
          <a:off x="4381207" y="98914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Rectangle 4"/>
          <p:cNvSpPr/>
          <p:nvPr/>
        </p:nvSpPr>
        <p:spPr>
          <a:xfrm>
            <a:off x="257419" y="20935"/>
            <a:ext cx="829391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Additional file Figure </a:t>
            </a:r>
            <a:r>
              <a:rPr lang="en-US" dirty="0" smtClean="0"/>
              <a:t>S2a. </a:t>
            </a:r>
            <a:r>
              <a:rPr lang="en-US" dirty="0"/>
              <a:t>Graphical representation of combination growth inhibition </a:t>
            </a:r>
            <a:r>
              <a:rPr lang="en-US" dirty="0" smtClean="0"/>
              <a:t>data for  FA8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355923" y="6099137"/>
            <a:ext cx="85168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The concentration of A</a:t>
            </a:r>
            <a:r>
              <a:rPr lang="en-US" i="1" dirty="0"/>
              <a:t>. cordifolia </a:t>
            </a:r>
            <a:r>
              <a:rPr lang="en-US" dirty="0" smtClean="0"/>
              <a:t>is written </a:t>
            </a:r>
            <a:r>
              <a:rPr lang="en-US" dirty="0"/>
              <a:t>on the left of the + </a:t>
            </a:r>
            <a:r>
              <a:rPr lang="en-US" dirty="0" smtClean="0"/>
              <a:t>sign and the concentration of </a:t>
            </a:r>
            <a:r>
              <a:rPr lang="en-US" i="1" dirty="0"/>
              <a:t>M. </a:t>
            </a:r>
            <a:r>
              <a:rPr lang="en-US" i="1" dirty="0" err="1"/>
              <a:t>indica</a:t>
            </a:r>
            <a:r>
              <a:rPr lang="en-US" dirty="0"/>
              <a:t> </a:t>
            </a:r>
            <a:r>
              <a:rPr lang="en-US" dirty="0" smtClean="0"/>
              <a:t>is written </a:t>
            </a:r>
            <a:r>
              <a:rPr lang="en-US" dirty="0"/>
              <a:t>on the right of the + </a:t>
            </a:r>
            <a:r>
              <a:rPr lang="en-US" dirty="0" smtClean="0"/>
              <a:t>sign. Concentrations of the extracts are </a:t>
            </a:r>
            <a:r>
              <a:rPr lang="en-US" dirty="0"/>
              <a:t>μg/ml </a:t>
            </a:r>
          </a:p>
        </p:txBody>
      </p:sp>
    </p:spTree>
    <p:extLst>
      <p:ext uri="{BB962C8B-B14F-4D97-AF65-F5344CB8AC3E}">
        <p14:creationId xmlns:p14="http://schemas.microsoft.com/office/powerpoint/2010/main" val="22788931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73258877"/>
              </p:ext>
            </p:extLst>
          </p:nvPr>
        </p:nvGraphicFramePr>
        <p:xfrm>
          <a:off x="114332" y="920072"/>
          <a:ext cx="4276693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14445852"/>
              </p:ext>
            </p:extLst>
          </p:nvPr>
        </p:nvGraphicFramePr>
        <p:xfrm>
          <a:off x="2861734" y="3563736"/>
          <a:ext cx="4276693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69971903"/>
              </p:ext>
            </p:extLst>
          </p:nvPr>
        </p:nvGraphicFramePr>
        <p:xfrm>
          <a:off x="4276693" y="92007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Rectangle 4"/>
          <p:cNvSpPr/>
          <p:nvPr/>
        </p:nvSpPr>
        <p:spPr>
          <a:xfrm>
            <a:off x="338667" y="181339"/>
            <a:ext cx="836506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Additional file </a:t>
            </a:r>
            <a:r>
              <a:rPr lang="en-US"/>
              <a:t>Figure </a:t>
            </a:r>
            <a:r>
              <a:rPr lang="en-US" smtClean="0"/>
              <a:t>S2a. </a:t>
            </a:r>
            <a:r>
              <a:rPr lang="en-US" dirty="0"/>
              <a:t>Graphical representation of combination growth inhibition </a:t>
            </a:r>
            <a:r>
              <a:rPr lang="en-US" dirty="0" smtClean="0"/>
              <a:t>data for CamWT_580Y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220734" y="6099137"/>
            <a:ext cx="85168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The concentration of A</a:t>
            </a:r>
            <a:r>
              <a:rPr lang="en-US" i="1" dirty="0"/>
              <a:t>. cordifolia </a:t>
            </a:r>
            <a:r>
              <a:rPr lang="en-US" dirty="0" smtClean="0"/>
              <a:t>is written </a:t>
            </a:r>
            <a:r>
              <a:rPr lang="en-US" dirty="0"/>
              <a:t>on the left of the + </a:t>
            </a:r>
            <a:r>
              <a:rPr lang="en-US" dirty="0" smtClean="0"/>
              <a:t>sign and the concentration of </a:t>
            </a:r>
            <a:r>
              <a:rPr lang="en-US" i="1" dirty="0"/>
              <a:t>M. </a:t>
            </a:r>
            <a:r>
              <a:rPr lang="en-US" i="1" dirty="0" err="1"/>
              <a:t>indica</a:t>
            </a:r>
            <a:r>
              <a:rPr lang="en-US" dirty="0"/>
              <a:t> </a:t>
            </a:r>
            <a:r>
              <a:rPr lang="en-US" dirty="0" smtClean="0"/>
              <a:t>is written </a:t>
            </a:r>
            <a:r>
              <a:rPr lang="en-US" dirty="0"/>
              <a:t>on the right of the + </a:t>
            </a:r>
            <a:r>
              <a:rPr lang="en-US" dirty="0" smtClean="0"/>
              <a:t>sign. Concentrations of the extracts are </a:t>
            </a:r>
            <a:r>
              <a:rPr lang="en-US" dirty="0"/>
              <a:t>μg/ml </a:t>
            </a:r>
          </a:p>
        </p:txBody>
      </p:sp>
    </p:spTree>
    <p:extLst>
      <p:ext uri="{BB962C8B-B14F-4D97-AF65-F5344CB8AC3E}">
        <p14:creationId xmlns:p14="http://schemas.microsoft.com/office/powerpoint/2010/main" val="7616128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</TotalTime>
  <Words>451</Words>
  <Application>Microsoft Macintosh PowerPoint</Application>
  <PresentationFormat>On-screen Show (4:3)</PresentationFormat>
  <Paragraphs>25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nda</dc:creator>
  <cp:lastModifiedBy>Linda</cp:lastModifiedBy>
  <cp:revision>6</cp:revision>
  <dcterms:created xsi:type="dcterms:W3CDTF">2020-03-30T23:29:45Z</dcterms:created>
  <dcterms:modified xsi:type="dcterms:W3CDTF">2020-07-25T13:15:30Z</dcterms:modified>
</cp:coreProperties>
</file>